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8" d="100"/>
          <a:sy n="88" d="100"/>
        </p:scale>
        <p:origin x="57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D:\Tutto%20lavoro\Lavori\Lav%20IPO7\New%20Submission2018\submission%20revision\MTT\Copia%20di%20MTT%2048h%20K562%20LAMA%20solo%20e%20comb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D:\Tutto%20lavoro\Lavori\Lav%20IPO7\New%20Submission2018\submission%20revision\MTT\Copia%20di%20MTT%2048h%20K562%20LAMA%20solo%20e%20comb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Tutto%20lavoro\Lavori\Lav%20IPO7\New%20Submission2018\submission%20revision\MTT\Copia%20di%20MTT%2048h%20K562%20LAMA%20solo%20e%20comb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Tutto%20lavoro\Lavori\Lav%20IPO7\New%20Submission2018\submission%20revision\MTT\Copia%20di%20MTT%2048h%20K562%20LAMA%20solo%20e%20comb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Riepilogo K562_2'!$L$27</c:f>
              <c:strCache>
                <c:ptCount val="1"/>
                <c:pt idx="0">
                  <c:v>IM</c:v>
                </c:pt>
              </c:strCache>
            </c:strRef>
          </c:tx>
          <c:spPr>
            <a:ln w="22225" cap="rnd">
              <a:solidFill>
                <a:schemeClr val="accent2"/>
              </a:solidFill>
              <a:round/>
            </a:ln>
            <a:effectLst/>
          </c:spPr>
          <c:marker>
            <c:symbol val="diamond"/>
            <c:size val="6"/>
            <c:spPr>
              <a:solidFill>
                <a:schemeClr val="accent2"/>
              </a:solidFill>
              <a:ln w="9525">
                <a:solidFill>
                  <a:schemeClr val="accent2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iepilogo K562_2'!$O$28:$O$33</c:f>
                <c:numCache>
                  <c:formatCode>General</c:formatCode>
                  <c:ptCount val="6"/>
                  <c:pt idx="0">
                    <c:v>1.5641127549332878</c:v>
                  </c:pt>
                  <c:pt idx="1">
                    <c:v>1.7960058940095622</c:v>
                  </c:pt>
                  <c:pt idx="2">
                    <c:v>2.6438234070148869</c:v>
                  </c:pt>
                  <c:pt idx="3">
                    <c:v>1.1115455858940446</c:v>
                  </c:pt>
                  <c:pt idx="4">
                    <c:v>3.4802596785369548</c:v>
                  </c:pt>
                  <c:pt idx="5">
                    <c:v>3.9396073778812322</c:v>
                  </c:pt>
                </c:numCache>
              </c:numRef>
            </c:plus>
            <c:minus>
              <c:numRef>
                <c:f>'Riepilogo K562_2'!$O$28:$O$33</c:f>
                <c:numCache>
                  <c:formatCode>General</c:formatCode>
                  <c:ptCount val="6"/>
                  <c:pt idx="0">
                    <c:v>1.5641127549332878</c:v>
                  </c:pt>
                  <c:pt idx="1">
                    <c:v>1.7960058940095622</c:v>
                  </c:pt>
                  <c:pt idx="2">
                    <c:v>2.6438234070148869</c:v>
                  </c:pt>
                  <c:pt idx="3">
                    <c:v>1.1115455858940446</c:v>
                  </c:pt>
                  <c:pt idx="4">
                    <c:v>3.4802596785369548</c:v>
                  </c:pt>
                  <c:pt idx="5">
                    <c:v>3.939607377881232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Riepilogo K562_2'!$L$28:$L$33</c:f>
              <c:numCache>
                <c:formatCode>0.0</c:formatCode>
                <c:ptCount val="6"/>
                <c:pt idx="0" formatCode="0">
                  <c:v>100.41824598091752</c:v>
                </c:pt>
                <c:pt idx="1">
                  <c:v>65.72402354361931</c:v>
                </c:pt>
                <c:pt idx="2">
                  <c:v>51.798066001001423</c:v>
                </c:pt>
                <c:pt idx="3">
                  <c:v>32.724409148672798</c:v>
                </c:pt>
                <c:pt idx="4">
                  <c:v>31.561998248206436</c:v>
                </c:pt>
                <c:pt idx="5">
                  <c:v>28.7392783679390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Riepilogo K562_2'!$M$27</c:f>
              <c:strCache>
                <c:ptCount val="1"/>
                <c:pt idx="0">
                  <c:v>Curcumin</c:v>
                </c:pt>
              </c:strCache>
            </c:strRef>
          </c:tx>
          <c:spPr>
            <a:ln w="22225" cap="rnd">
              <a:solidFill>
                <a:schemeClr val="accent4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chemeClr val="accent4"/>
              </a:solidFill>
              <a:ln w="9525">
                <a:solidFill>
                  <a:schemeClr val="accent4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iepilogo K562_2'!$P$28:$P$33</c:f>
                <c:numCache>
                  <c:formatCode>General</c:formatCode>
                  <c:ptCount val="6"/>
                  <c:pt idx="0">
                    <c:v>2.7999909706444641</c:v>
                  </c:pt>
                  <c:pt idx="1">
                    <c:v>4.6918089332589483</c:v>
                  </c:pt>
                  <c:pt idx="2">
                    <c:v>7.3322638169347769</c:v>
                  </c:pt>
                  <c:pt idx="3">
                    <c:v>5.2120126553559576</c:v>
                  </c:pt>
                  <c:pt idx="4">
                    <c:v>2.1806442253111373</c:v>
                  </c:pt>
                  <c:pt idx="5">
                    <c:v>1.7950979355072476</c:v>
                  </c:pt>
                </c:numCache>
              </c:numRef>
            </c:plus>
            <c:minus>
              <c:numRef>
                <c:f>'Riepilogo K562_2'!$P$28:$P$33</c:f>
                <c:numCache>
                  <c:formatCode>General</c:formatCode>
                  <c:ptCount val="6"/>
                  <c:pt idx="0">
                    <c:v>2.7999909706444641</c:v>
                  </c:pt>
                  <c:pt idx="1">
                    <c:v>4.6918089332589483</c:v>
                  </c:pt>
                  <c:pt idx="2">
                    <c:v>7.3322638169347769</c:v>
                  </c:pt>
                  <c:pt idx="3">
                    <c:v>5.2120126553559576</c:v>
                  </c:pt>
                  <c:pt idx="4">
                    <c:v>2.1806442253111373</c:v>
                  </c:pt>
                  <c:pt idx="5">
                    <c:v>1.7950979355072476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Riepilogo K562_2'!$M$28:$M$33</c:f>
              <c:numCache>
                <c:formatCode>0.0</c:formatCode>
                <c:ptCount val="6"/>
                <c:pt idx="0" formatCode="0">
                  <c:v>100.23683927225751</c:v>
                </c:pt>
                <c:pt idx="1">
                  <c:v>88.880778387008903</c:v>
                </c:pt>
                <c:pt idx="2">
                  <c:v>83.633041411529419</c:v>
                </c:pt>
                <c:pt idx="3">
                  <c:v>38.1282325928616</c:v>
                </c:pt>
                <c:pt idx="4">
                  <c:v>20.373661003351351</c:v>
                </c:pt>
                <c:pt idx="5">
                  <c:v>19.724520699559694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Riepilogo K562_2'!$N$27</c:f>
              <c:strCache>
                <c:ptCount val="1"/>
                <c:pt idx="0">
                  <c:v>IM+Curcumin</c:v>
                </c:pt>
              </c:strCache>
            </c:strRef>
          </c:tx>
          <c:spPr>
            <a:ln w="22225" cap="rnd">
              <a:solidFill>
                <a:schemeClr val="accent6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chemeClr val="accent6"/>
              </a:solidFill>
              <a:ln w="9525">
                <a:solidFill>
                  <a:schemeClr val="accent6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iepilogo K562_2'!$Q$28:$Q$33</c:f>
                <c:numCache>
                  <c:formatCode>General</c:formatCode>
                  <c:ptCount val="6"/>
                  <c:pt idx="0">
                    <c:v>2.4404415956238839</c:v>
                  </c:pt>
                  <c:pt idx="1">
                    <c:v>5.0829209431202882</c:v>
                  </c:pt>
                  <c:pt idx="2">
                    <c:v>4.1179206214804607</c:v>
                  </c:pt>
                  <c:pt idx="3">
                    <c:v>3.3432909473748151</c:v>
                  </c:pt>
                  <c:pt idx="4">
                    <c:v>3.1551429503787904</c:v>
                  </c:pt>
                  <c:pt idx="5">
                    <c:v>1.5679903570239211</c:v>
                  </c:pt>
                </c:numCache>
              </c:numRef>
            </c:plus>
            <c:minus>
              <c:numRef>
                <c:f>'Riepilogo K562_2'!$Q$28:$Q$33</c:f>
                <c:numCache>
                  <c:formatCode>General</c:formatCode>
                  <c:ptCount val="6"/>
                  <c:pt idx="0">
                    <c:v>2.4404415956238839</c:v>
                  </c:pt>
                  <c:pt idx="1">
                    <c:v>5.0829209431202882</c:v>
                  </c:pt>
                  <c:pt idx="2">
                    <c:v>4.1179206214804607</c:v>
                  </c:pt>
                  <c:pt idx="3">
                    <c:v>3.3432909473748151</c:v>
                  </c:pt>
                  <c:pt idx="4">
                    <c:v>3.1551429503787904</c:v>
                  </c:pt>
                  <c:pt idx="5">
                    <c:v>1.5679903570239211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Riepilogo K562_2'!$N$28:$N$33</c:f>
              <c:numCache>
                <c:formatCode>0.0</c:formatCode>
                <c:ptCount val="6"/>
                <c:pt idx="0" formatCode="0">
                  <c:v>100.33401849948612</c:v>
                </c:pt>
                <c:pt idx="1">
                  <c:v>27.786603990913655</c:v>
                </c:pt>
                <c:pt idx="2">
                  <c:v>26.183556980498022</c:v>
                </c:pt>
                <c:pt idx="3">
                  <c:v>24.197596999917504</c:v>
                </c:pt>
                <c:pt idx="4">
                  <c:v>24.629063538138237</c:v>
                </c:pt>
                <c:pt idx="5">
                  <c:v>16.41570836501161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6516928"/>
        <c:axId val="136516536"/>
      </c:lineChart>
      <c:catAx>
        <c:axId val="136516928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all" spc="120" normalizeH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36516536"/>
        <c:crosses val="autoZero"/>
        <c:auto val="1"/>
        <c:lblAlgn val="ctr"/>
        <c:lblOffset val="100"/>
        <c:noMultiLvlLbl val="0"/>
      </c:catAx>
      <c:valAx>
        <c:axId val="136516536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36516928"/>
        <c:crossesAt val="1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75730008748906386"/>
          <c:y val="8.3333333333333329E-2"/>
          <c:w val="0.23817760279965006"/>
          <c:h val="0.153070501603966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it-I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1577564703153823E-2"/>
          <c:y val="5.0925925925925923E-2"/>
          <c:w val="0.79842195300647756"/>
          <c:h val="0.8377930883639545"/>
        </c:manualLayout>
      </c:layout>
      <c:lineChart>
        <c:grouping val="standard"/>
        <c:varyColors val="0"/>
        <c:ser>
          <c:idx val="0"/>
          <c:order val="0"/>
          <c:tx>
            <c:strRef>
              <c:f>'Riepilogo LAMA84_2'!$L$26</c:f>
              <c:strCache>
                <c:ptCount val="1"/>
                <c:pt idx="0">
                  <c:v>IM</c:v>
                </c:pt>
              </c:strCache>
            </c:strRef>
          </c:tx>
          <c:spPr>
            <a:ln w="22225" cap="rnd">
              <a:solidFill>
                <a:srgbClr val="7030A0"/>
              </a:solidFill>
              <a:round/>
            </a:ln>
            <a:effectLst/>
          </c:spPr>
          <c:marker>
            <c:symbol val="diamond"/>
            <c:size val="6"/>
            <c:spPr>
              <a:solidFill>
                <a:srgbClr val="7030A0"/>
              </a:solidFill>
              <a:ln w="9525">
                <a:solidFill>
                  <a:srgbClr val="7030A0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iepilogo LAMA84_2'!$O$27:$O$32</c:f>
                <c:numCache>
                  <c:formatCode>General</c:formatCode>
                  <c:ptCount val="6"/>
                  <c:pt idx="0">
                    <c:v>0.79833005099576704</c:v>
                  </c:pt>
                  <c:pt idx="1">
                    <c:v>4.6397359428985796</c:v>
                  </c:pt>
                  <c:pt idx="2">
                    <c:v>1.5964808170935252</c:v>
                  </c:pt>
                  <c:pt idx="3">
                    <c:v>2.9332074812816855</c:v>
                  </c:pt>
                  <c:pt idx="4">
                    <c:v>2.1766555023869589</c:v>
                  </c:pt>
                  <c:pt idx="5">
                    <c:v>2.9277680219138658</c:v>
                  </c:pt>
                </c:numCache>
              </c:numRef>
            </c:plus>
            <c:minus>
              <c:numRef>
                <c:f>'Riepilogo LAMA84_2'!$O$27:$O$32</c:f>
                <c:numCache>
                  <c:formatCode>General</c:formatCode>
                  <c:ptCount val="6"/>
                  <c:pt idx="0">
                    <c:v>0.79833005099576704</c:v>
                  </c:pt>
                  <c:pt idx="1">
                    <c:v>4.6397359428985796</c:v>
                  </c:pt>
                  <c:pt idx="2">
                    <c:v>1.5964808170935252</c:v>
                  </c:pt>
                  <c:pt idx="3">
                    <c:v>2.9332074812816855</c:v>
                  </c:pt>
                  <c:pt idx="4">
                    <c:v>2.1766555023869589</c:v>
                  </c:pt>
                  <c:pt idx="5">
                    <c:v>2.9277680219138658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Riepilogo LAMA84_2'!$L$27:$L$32</c:f>
              <c:numCache>
                <c:formatCode>0.0</c:formatCode>
                <c:ptCount val="6"/>
                <c:pt idx="0" formatCode="0">
                  <c:v>99.863058720420668</c:v>
                </c:pt>
                <c:pt idx="1">
                  <c:v>46.932515337423318</c:v>
                </c:pt>
                <c:pt idx="2">
                  <c:v>26.329641657126139</c:v>
                </c:pt>
                <c:pt idx="3">
                  <c:v>16.31053594948073</c:v>
                </c:pt>
                <c:pt idx="4">
                  <c:v>15.976777352497553</c:v>
                </c:pt>
                <c:pt idx="5">
                  <c:v>15.37051730004797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Riepilogo LAMA84_2'!$M$26</c:f>
              <c:strCache>
                <c:ptCount val="1"/>
                <c:pt idx="0">
                  <c:v>Curcumin</c:v>
                </c:pt>
              </c:strCache>
            </c:strRef>
          </c:tx>
          <c:spPr>
            <a:ln w="22225" cap="rnd">
              <a:solidFill>
                <a:srgbClr val="5B9BD5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rgbClr val="5B9BD5"/>
              </a:solidFill>
              <a:ln w="9525">
                <a:solidFill>
                  <a:srgbClr val="5B9BD5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iepilogo LAMA84_2'!$P$27:$P$32</c:f>
                <c:numCache>
                  <c:formatCode>General</c:formatCode>
                  <c:ptCount val="6"/>
                  <c:pt idx="0">
                    <c:v>4.1434820162220793</c:v>
                  </c:pt>
                  <c:pt idx="1">
                    <c:v>4.3076977095902649</c:v>
                  </c:pt>
                  <c:pt idx="2">
                    <c:v>6.9808876530309698</c:v>
                  </c:pt>
                  <c:pt idx="3">
                    <c:v>2.2301405247161803</c:v>
                  </c:pt>
                  <c:pt idx="4">
                    <c:v>4.734256660998823</c:v>
                  </c:pt>
                  <c:pt idx="5">
                    <c:v>3.2889937202209789</c:v>
                  </c:pt>
                </c:numCache>
              </c:numRef>
            </c:plus>
            <c:minus>
              <c:numRef>
                <c:f>'Riepilogo LAMA84_2'!$P$27:$P$32</c:f>
                <c:numCache>
                  <c:formatCode>General</c:formatCode>
                  <c:ptCount val="6"/>
                  <c:pt idx="0">
                    <c:v>4.1434820162220793</c:v>
                  </c:pt>
                  <c:pt idx="1">
                    <c:v>4.3076977095902649</c:v>
                  </c:pt>
                  <c:pt idx="2">
                    <c:v>6.9808876530309698</c:v>
                  </c:pt>
                  <c:pt idx="3">
                    <c:v>2.2301405247161803</c:v>
                  </c:pt>
                  <c:pt idx="4">
                    <c:v>4.734256660998823</c:v>
                  </c:pt>
                  <c:pt idx="5">
                    <c:v>3.2889937202209789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Riepilogo LAMA84_2'!$M$27:$M$32</c:f>
              <c:numCache>
                <c:formatCode>0.0</c:formatCode>
                <c:ptCount val="6"/>
                <c:pt idx="0" formatCode="0">
                  <c:v>99.961389961389955</c:v>
                </c:pt>
                <c:pt idx="1">
                  <c:v>87.05592221184223</c:v>
                </c:pt>
                <c:pt idx="2">
                  <c:v>74.161572978439125</c:v>
                </c:pt>
                <c:pt idx="3">
                  <c:v>24.713479105366339</c:v>
                </c:pt>
                <c:pt idx="4">
                  <c:v>23.444943849570027</c:v>
                </c:pt>
                <c:pt idx="5">
                  <c:v>22.336786311624472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Riepilogo LAMA84_2'!$N$26</c:f>
              <c:strCache>
                <c:ptCount val="1"/>
                <c:pt idx="0">
                  <c:v>IM+Curcumin</c:v>
                </c:pt>
              </c:strCache>
            </c:strRef>
          </c:tx>
          <c:spPr>
            <a:ln w="22225" cap="rnd">
              <a:solidFill>
                <a:srgbClr val="C0000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rgbClr val="C00000"/>
              </a:solidFill>
              <a:ln w="9525">
                <a:solidFill>
                  <a:srgbClr val="C00000"/>
                </a:solidFill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iepilogo LAMA84_2'!$Q$27:$Q$32</c:f>
                <c:numCache>
                  <c:formatCode>General</c:formatCode>
                  <c:ptCount val="6"/>
                  <c:pt idx="0">
                    <c:v>1.4990833802679173</c:v>
                  </c:pt>
                  <c:pt idx="1">
                    <c:v>1.9475507622349006</c:v>
                  </c:pt>
                  <c:pt idx="2">
                    <c:v>1.8178657118616453</c:v>
                  </c:pt>
                  <c:pt idx="3">
                    <c:v>1.4835452756416339</c:v>
                  </c:pt>
                  <c:pt idx="4">
                    <c:v>1.6820877365360078</c:v>
                  </c:pt>
                  <c:pt idx="5">
                    <c:v>0.40203149395047266</c:v>
                  </c:pt>
                </c:numCache>
              </c:numRef>
            </c:plus>
            <c:minus>
              <c:numRef>
                <c:f>'Riepilogo LAMA84_2'!$Q$27:$Q$32</c:f>
                <c:numCache>
                  <c:formatCode>General</c:formatCode>
                  <c:ptCount val="6"/>
                  <c:pt idx="0">
                    <c:v>1.4990833802679173</c:v>
                  </c:pt>
                  <c:pt idx="1">
                    <c:v>1.9475507622349006</c:v>
                  </c:pt>
                  <c:pt idx="2">
                    <c:v>1.8178657118616453</c:v>
                  </c:pt>
                  <c:pt idx="3">
                    <c:v>1.4835452756416339</c:v>
                  </c:pt>
                  <c:pt idx="4">
                    <c:v>1.6820877365360078</c:v>
                  </c:pt>
                  <c:pt idx="5">
                    <c:v>0.40203149395047266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Riepilogo LAMA84_2'!$N$27:$N$32</c:f>
              <c:numCache>
                <c:formatCode>0.0</c:formatCode>
                <c:ptCount val="6"/>
                <c:pt idx="0" formatCode="0">
                  <c:v>100.40288735940909</c:v>
                </c:pt>
                <c:pt idx="1">
                  <c:v>18.234779799368209</c:v>
                </c:pt>
                <c:pt idx="2">
                  <c:v>18.025364584056302</c:v>
                </c:pt>
                <c:pt idx="3">
                  <c:v>16.542168294664556</c:v>
                </c:pt>
                <c:pt idx="4">
                  <c:v>16.343906311671073</c:v>
                </c:pt>
                <c:pt idx="5">
                  <c:v>13.23454453889236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6518104"/>
        <c:axId val="136518496"/>
      </c:lineChart>
      <c:catAx>
        <c:axId val="13651810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all" spc="120" normalizeH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36518496"/>
        <c:crosses val="autoZero"/>
        <c:auto val="1"/>
        <c:lblAlgn val="ctr"/>
        <c:lblOffset val="100"/>
        <c:noMultiLvlLbl val="0"/>
      </c:catAx>
      <c:valAx>
        <c:axId val="136518496"/>
        <c:scaling>
          <c:orientation val="minMax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36518104"/>
        <c:crossesAt val="1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2630236602576348"/>
          <c:y val="1.4632907589651193E-2"/>
          <c:w val="0.25459403975897138"/>
          <c:h val="0.175384479282584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it-I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958355205599299"/>
          <c:y val="5.0925925925925923E-2"/>
          <c:w val="0.82081933508311467"/>
          <c:h val="0.75240740740740741"/>
        </c:manualLayout>
      </c:layout>
      <c:scatterChart>
        <c:scatterStyle val="lineMarker"/>
        <c:varyColors val="0"/>
        <c:ser>
          <c:idx val="0"/>
          <c:order val="0"/>
          <c:tx>
            <c:strRef>
              <c:f>'Riepilogo K562_2'!$C$48</c:f>
              <c:strCache>
                <c:ptCount val="1"/>
                <c:pt idx="0">
                  <c:v>CI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triangle"/>
              <c:size val="7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</c:dPt>
          <c:dPt>
            <c:idx val="1"/>
            <c:marker>
              <c:symbol val="diamond"/>
              <c:size val="7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</c:dPt>
          <c:dPt>
            <c:idx val="3"/>
            <c:marker>
              <c:symbol val="square"/>
              <c:size val="7"/>
              <c:spPr>
                <a:solidFill>
                  <a:sysClr val="window" lastClr="FFFFFF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</c:dPt>
          <c:dPt>
            <c:idx val="4"/>
            <c:marker>
              <c:symbol val="circle"/>
              <c:size val="7"/>
              <c:spPr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</c:dPt>
          <c:xVal>
            <c:numRef>
              <c:f>'Riepilogo K562_2'!$B$49:$B$53</c:f>
              <c:numCache>
                <c:formatCode>General</c:formatCode>
                <c:ptCount val="5"/>
                <c:pt idx="0">
                  <c:v>0.27800000000000002</c:v>
                </c:pt>
                <c:pt idx="1">
                  <c:v>0.26200000000000001</c:v>
                </c:pt>
                <c:pt idx="2">
                  <c:v>0.24199999999999999</c:v>
                </c:pt>
                <c:pt idx="3">
                  <c:v>0.246</c:v>
                </c:pt>
                <c:pt idx="4">
                  <c:v>0.16400000000000001</c:v>
                </c:pt>
              </c:numCache>
            </c:numRef>
          </c:xVal>
          <c:yVal>
            <c:numRef>
              <c:f>'Riepilogo K562_2'!$C$49:$C$53</c:f>
              <c:numCache>
                <c:formatCode>General</c:formatCode>
                <c:ptCount val="5"/>
                <c:pt idx="0">
                  <c:v>0.62824999999999998</c:v>
                </c:pt>
                <c:pt idx="1">
                  <c:v>0.62390000000000001</c:v>
                </c:pt>
                <c:pt idx="2">
                  <c:v>0.64468999999999999</c:v>
                </c:pt>
                <c:pt idx="3">
                  <c:v>0.78081999999999996</c:v>
                </c:pt>
                <c:pt idx="4">
                  <c:v>0.7299600000000000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8131944"/>
        <c:axId val="138132728"/>
      </c:scatterChart>
      <c:valAx>
        <c:axId val="138131944"/>
        <c:scaling>
          <c:orientation val="minMax"/>
          <c:max val="0.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 dirty="0" err="1" smtClean="0"/>
                  <a:t>FrAf</a:t>
                </a:r>
                <a:endParaRPr lang="it-IT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it-IT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38132728"/>
        <c:crosses val="autoZero"/>
        <c:crossBetween val="midCat"/>
      </c:valAx>
      <c:valAx>
        <c:axId val="138132728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>
                    <a:solidFill>
                      <a:sysClr val="windowText" lastClr="000000"/>
                    </a:solidFill>
                  </a:rPr>
                  <a:t>CI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it-IT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38131944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Riepilogo LAMA84_2'!$C$49</c:f>
              <c:strCache>
                <c:ptCount val="1"/>
                <c:pt idx="0">
                  <c:v>CI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triangle"/>
              <c:size val="7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</c:dPt>
          <c:dPt>
            <c:idx val="1"/>
            <c:marker>
              <c:symbol val="diamond"/>
              <c:size val="7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</c:dPt>
          <c:dPt>
            <c:idx val="3"/>
            <c:marker>
              <c:symbol val="square"/>
              <c:size val="7"/>
              <c:spPr>
                <a:solidFill>
                  <a:sysClr val="window" lastClr="FFFFFF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</c:dPt>
          <c:dPt>
            <c:idx val="4"/>
            <c:marker>
              <c:symbol val="circle"/>
              <c:size val="7"/>
              <c:spPr>
                <a:solidFill>
                  <a:sysClr val="window" lastClr="FFFFFF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</c:dPt>
          <c:xVal>
            <c:numRef>
              <c:f>'Riepilogo LAMA84_2'!$B$50:$B$54</c:f>
              <c:numCache>
                <c:formatCode>0.000</c:formatCode>
                <c:ptCount val="5"/>
                <c:pt idx="0">
                  <c:v>0.182</c:v>
                </c:pt>
                <c:pt idx="1">
                  <c:v>0.18</c:v>
                </c:pt>
                <c:pt idx="2">
                  <c:v>0.16500000000000001</c:v>
                </c:pt>
                <c:pt idx="3">
                  <c:v>0.16300000000000001</c:v>
                </c:pt>
                <c:pt idx="4">
                  <c:v>0.13600000000000001</c:v>
                </c:pt>
              </c:numCache>
            </c:numRef>
          </c:xVal>
          <c:yVal>
            <c:numRef>
              <c:f>'Riepilogo LAMA84_2'!$C$50:$C$54</c:f>
              <c:numCache>
                <c:formatCode>General</c:formatCode>
                <c:ptCount val="5"/>
                <c:pt idx="0">
                  <c:v>0.51371</c:v>
                </c:pt>
                <c:pt idx="1">
                  <c:v>0.58992</c:v>
                </c:pt>
                <c:pt idx="2">
                  <c:v>0.70633999999999997</c:v>
                </c:pt>
                <c:pt idx="3">
                  <c:v>0.99019000000000001</c:v>
                </c:pt>
                <c:pt idx="4">
                  <c:v>1.8541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8133120"/>
        <c:axId val="138133512"/>
      </c:scatterChart>
      <c:valAx>
        <c:axId val="138133120"/>
        <c:scaling>
          <c:orientation val="minMax"/>
          <c:max val="0.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 dirty="0" err="1" smtClean="0"/>
                  <a:t>FrAf</a:t>
                </a:r>
                <a:endParaRPr lang="it-IT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it-IT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38133512"/>
        <c:crosses val="autoZero"/>
        <c:crossBetween val="midCat"/>
        <c:majorUnit val="0.1"/>
      </c:valAx>
      <c:valAx>
        <c:axId val="138133512"/>
        <c:scaling>
          <c:orientation val="minMax"/>
          <c:max val="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/>
                  <a:t>CI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it-IT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38133120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800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8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11B91-501D-4F26-8E0F-B0B649F74738}" type="datetimeFigureOut">
              <a:rPr lang="it-IT" smtClean="0"/>
              <a:t>26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D693-4B50-45CE-8489-6DA606A8A98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3269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11B91-501D-4F26-8E0F-B0B649F74738}" type="datetimeFigureOut">
              <a:rPr lang="it-IT" smtClean="0"/>
              <a:t>26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D693-4B50-45CE-8489-6DA606A8A98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26206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11B91-501D-4F26-8E0F-B0B649F74738}" type="datetimeFigureOut">
              <a:rPr lang="it-IT" smtClean="0"/>
              <a:t>26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D693-4B50-45CE-8489-6DA606A8A98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4521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11B91-501D-4F26-8E0F-B0B649F74738}" type="datetimeFigureOut">
              <a:rPr lang="it-IT" smtClean="0"/>
              <a:t>26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D693-4B50-45CE-8489-6DA606A8A98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92340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11B91-501D-4F26-8E0F-B0B649F74738}" type="datetimeFigureOut">
              <a:rPr lang="it-IT" smtClean="0"/>
              <a:t>26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D693-4B50-45CE-8489-6DA606A8A98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4299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11B91-501D-4F26-8E0F-B0B649F74738}" type="datetimeFigureOut">
              <a:rPr lang="it-IT" smtClean="0"/>
              <a:t>26/06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D693-4B50-45CE-8489-6DA606A8A98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4325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11B91-501D-4F26-8E0F-B0B649F74738}" type="datetimeFigureOut">
              <a:rPr lang="it-IT" smtClean="0"/>
              <a:t>26/06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D693-4B50-45CE-8489-6DA606A8A98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90892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11B91-501D-4F26-8E0F-B0B649F74738}" type="datetimeFigureOut">
              <a:rPr lang="it-IT" smtClean="0"/>
              <a:t>26/06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D693-4B50-45CE-8489-6DA606A8A98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10854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11B91-501D-4F26-8E0F-B0B649F74738}" type="datetimeFigureOut">
              <a:rPr lang="it-IT" smtClean="0"/>
              <a:t>26/06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D693-4B50-45CE-8489-6DA606A8A98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8123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11B91-501D-4F26-8E0F-B0B649F74738}" type="datetimeFigureOut">
              <a:rPr lang="it-IT" smtClean="0"/>
              <a:t>26/06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D693-4B50-45CE-8489-6DA606A8A98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3973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11B91-501D-4F26-8E0F-B0B649F74738}" type="datetimeFigureOut">
              <a:rPr lang="it-IT" smtClean="0"/>
              <a:t>26/06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AD693-4B50-45CE-8489-6DA606A8A98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8861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111B91-501D-4F26-8E0F-B0B649F74738}" type="datetimeFigureOut">
              <a:rPr lang="it-IT" smtClean="0"/>
              <a:t>26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4AD693-4B50-45CE-8489-6DA606A8A98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8468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1" y="113861"/>
            <a:ext cx="11941358" cy="6569917"/>
            <a:chOff x="1" y="113861"/>
            <a:chExt cx="11941358" cy="6569917"/>
          </a:xfrm>
        </p:grpSpPr>
        <p:sp>
          <p:nvSpPr>
            <p:cNvPr id="15" name="Rettangolo 14"/>
            <p:cNvSpPr/>
            <p:nvPr/>
          </p:nvSpPr>
          <p:spPr>
            <a:xfrm>
              <a:off x="1" y="5237228"/>
              <a:ext cx="11941358" cy="144655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1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ure S7.</a:t>
              </a:r>
              <a:r>
                <a:rPr lang="it-IT" sz="1100" b="1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ti-proliferative </a:t>
              </a:r>
              <a:r>
                <a:rPr lang="it-IT" sz="1100" b="1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s</a:t>
              </a:r>
              <a:r>
                <a:rPr lang="it-IT" sz="1100" b="1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it-IT" sz="1100" b="1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rcumin</a:t>
              </a:r>
              <a:r>
                <a:rPr lang="it-IT" sz="1100" b="1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it-IT" sz="1100" b="1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atinib</a:t>
              </a:r>
              <a:r>
                <a:rPr lang="it-IT" sz="1100" b="1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it-IT" sz="1100" b="1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rcumin+imatinib</a:t>
              </a:r>
              <a:r>
                <a:rPr lang="it-IT" sz="1100" b="1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100" b="1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bination</a:t>
              </a:r>
              <a:r>
                <a:rPr lang="it-IT" sz="1100" b="1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n CML </a:t>
              </a:r>
              <a:r>
                <a:rPr lang="it-IT" sz="1100" b="1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</a:t>
              </a:r>
              <a:r>
                <a:rPr lang="it-IT" sz="1100" b="1" i="0" u="none" strike="noStrike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100" b="1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iability</a:t>
              </a:r>
              <a:r>
                <a:rPr lang="it-IT" sz="1100" b="1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it-IT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rcumin</a:t>
              </a:r>
              <a:r>
                <a:rPr lang="it-IT" sz="1100" b="0" i="0" u="none" strike="noStrike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it-IT" sz="1100" b="0" i="0" u="none" strike="noStrike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atinib</a:t>
              </a:r>
              <a:r>
                <a:rPr lang="it-IT" sz="1100" b="0" i="0" u="none" strike="noStrike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re tested for their anti-proliferative effects on K562 (</a:t>
              </a:r>
              <a:r>
                <a:rPr lang="en-US" sz="1100" b="1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LAMA84 cells (</a:t>
              </a:r>
              <a:r>
                <a:rPr lang="en-US" sz="1100" b="1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</a:t>
              </a:r>
              <a:r>
                <a:rPr lang="en-US" sz="1100" b="0" i="0" u="none" strike="noStrike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he assays were performed by using curcumin and </a:t>
              </a:r>
              <a:r>
                <a:rPr lang="en-US" sz="1100" b="0" i="0" u="none" strike="noStrike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atinib</a:t>
              </a:r>
              <a:r>
                <a:rPr lang="en-US" sz="1100" b="0" i="0" u="none" strike="noStrike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ngly (using the reported doses) or in</a:t>
              </a:r>
              <a:r>
                <a:rPr lang="en-US" sz="1100" b="0" i="0" u="none" strike="noStrike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bination (20 </a:t>
              </a:r>
              <a:r>
                <a:rPr lang="en-US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urcumin held constant and </a:t>
              </a:r>
              <a:r>
                <a:rPr lang="en-US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atinib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t reported concentrations. In K562 cells combination compound treatments showed significant differences compared to singl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 </a:t>
              </a:r>
              <a:r>
                <a:rPr lang="en-US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atinib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reatments 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r all doses tested 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p&lt;0.001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 In 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MA84 cells 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bination compound treatments showed significant differences compared to single </a:t>
              </a:r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matinib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reatments for 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er doses 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sted (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&lt;0.001 at 0.1 and 0.2μM), while no 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gnificant differences were observed between combination compound and </a:t>
              </a:r>
              <a:r>
                <a:rPr lang="en-US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atinib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at 0.5-5 </a:t>
              </a:r>
              <a:r>
                <a:rPr lang="en-US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ecause high cell death occurred. Combination</a:t>
              </a:r>
              <a:r>
                <a:rPr lang="en-US" sz="1100" b="0" i="0" u="none" strike="noStrike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dex (CI) analysis of growth inhibition in 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562 (</a:t>
              </a:r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LAMA84 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 (</a:t>
              </a:r>
              <a:r>
                <a:rPr lang="en-US" sz="1100" b="1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fter 48 h incubation using curcumin (20 </a:t>
              </a:r>
              <a:r>
                <a:rPr lang="en-US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</a:t>
              </a:r>
              <a:r>
                <a:rPr lang="en-US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atinib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different concentrations). Data from Figure S6a and S6b were converted</a:t>
              </a:r>
              <a:r>
                <a:rPr lang="en-US" sz="1100" b="0" i="0" u="none" strike="noStrike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 Fraction Affected (</a:t>
              </a:r>
              <a:r>
                <a:rPr lang="en-US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Af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plotted against Combination Index (CI)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it-IT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ults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re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llows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</a:t>
              </a:r>
              <a:r>
                <a:rPr lang="it-IT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atinib</a:t>
              </a:r>
              <a:r>
                <a:rPr lang="it-IT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ntration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r>
                <a:rPr lang="it-IT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▲= 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 </a:t>
              </a:r>
              <a:r>
                <a:rPr lang="el-GR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; </a:t>
              </a:r>
              <a:r>
                <a:rPr lang="it-IT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♦ 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 0.2 </a:t>
              </a:r>
              <a:r>
                <a:rPr lang="el-GR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; ● = 0.5 </a:t>
              </a:r>
              <a:r>
                <a:rPr lang="el-GR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; □ = 1 </a:t>
              </a:r>
              <a:r>
                <a:rPr lang="el-GR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; </a:t>
              </a:r>
              <a:r>
                <a:rPr lang="el-GR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○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l-GR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 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el-G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μ</a:t>
              </a:r>
              <a:r>
                <a:rPr lang="it-IT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</a:t>
              </a:r>
              <a:r>
                <a:rPr lang="it-IT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aight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ine</a:t>
              </a:r>
              <a:r>
                <a:rPr lang="it-IT" sz="1100" b="0" i="0" u="none" strike="noStrike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n the graph designates a CI equal to 1. Combination Index interpretation was as follows: CI value of 1 indicates additivity; CI &lt;1 indicates synergism; and CI &gt;1 indicates</a:t>
              </a:r>
              <a:r>
                <a:rPr lang="en-US" sz="1100" b="0" i="0" u="none" strike="noStrike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100" b="0" i="0" u="none" strike="noStrike" baseline="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agonism</a:t>
              </a:r>
              <a:r>
                <a:rPr lang="it-IT" sz="1100" b="0" i="0" u="none" strike="noStrike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it-IT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" name="Gruppo 6"/>
            <p:cNvGrpSpPr/>
            <p:nvPr/>
          </p:nvGrpSpPr>
          <p:grpSpPr>
            <a:xfrm>
              <a:off x="272727" y="113861"/>
              <a:ext cx="5026026" cy="2939106"/>
              <a:chOff x="238662" y="303822"/>
              <a:chExt cx="5026026" cy="2939106"/>
            </a:xfrm>
          </p:grpSpPr>
          <p:graphicFrame>
            <p:nvGraphicFramePr>
              <p:cNvPr id="20" name="Grafico 1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62886907"/>
                  </p:ext>
                </p:extLst>
              </p:nvPr>
            </p:nvGraphicFramePr>
            <p:xfrm>
              <a:off x="692688" y="326906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2" name="CasellaDiTesto 21"/>
              <p:cNvSpPr txBox="1"/>
              <p:nvPr/>
            </p:nvSpPr>
            <p:spPr>
              <a:xfrm>
                <a:off x="392177" y="303822"/>
                <a:ext cx="31290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it-IT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CasellaDiTesto 23"/>
              <p:cNvSpPr txBox="1"/>
              <p:nvPr/>
            </p:nvSpPr>
            <p:spPr>
              <a:xfrm>
                <a:off x="238662" y="2996707"/>
                <a:ext cx="50260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urcumin</a:t>
                </a:r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µM</a:t>
                </a:r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      0                 5                 10              20                40                50 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" name="Rettangolo 2"/>
              <p:cNvSpPr/>
              <p:nvPr/>
            </p:nvSpPr>
            <p:spPr>
              <a:xfrm>
                <a:off x="1317171" y="2833938"/>
                <a:ext cx="3624943" cy="23068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" name="CasellaDiTesto 1"/>
              <p:cNvSpPr txBox="1"/>
              <p:nvPr/>
            </p:nvSpPr>
            <p:spPr>
              <a:xfrm>
                <a:off x="238662" y="2773735"/>
                <a:ext cx="47034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matinib</a:t>
                </a:r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µM)         0                0.1              0.2              0.5                1                 5 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" name="Gruppo 27"/>
            <p:cNvGrpSpPr/>
            <p:nvPr/>
          </p:nvGrpSpPr>
          <p:grpSpPr>
            <a:xfrm>
              <a:off x="6249759" y="115174"/>
              <a:ext cx="5556486" cy="2960315"/>
              <a:chOff x="6173559" y="303822"/>
              <a:chExt cx="5556486" cy="2960315"/>
            </a:xfrm>
          </p:grpSpPr>
          <p:graphicFrame>
            <p:nvGraphicFramePr>
              <p:cNvPr id="17" name="Grafico 1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7453562"/>
                  </p:ext>
                </p:extLst>
              </p:nvPr>
            </p:nvGraphicFramePr>
            <p:xfrm>
              <a:off x="6653304" y="479003"/>
              <a:ext cx="5076741" cy="257725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8" name="CasellaDiTesto 17"/>
              <p:cNvSpPr txBox="1"/>
              <p:nvPr/>
            </p:nvSpPr>
            <p:spPr>
              <a:xfrm>
                <a:off x="6226514" y="303822"/>
                <a:ext cx="3257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it-IT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ttangolo 24"/>
              <p:cNvSpPr/>
              <p:nvPr/>
            </p:nvSpPr>
            <p:spPr>
              <a:xfrm>
                <a:off x="7250573" y="2857707"/>
                <a:ext cx="4124998" cy="2294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6" name="CasellaDiTesto 25"/>
              <p:cNvSpPr txBox="1"/>
              <p:nvPr/>
            </p:nvSpPr>
            <p:spPr>
              <a:xfrm>
                <a:off x="6173559" y="3017916"/>
                <a:ext cx="50260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urcumin</a:t>
                </a:r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µM</a:t>
                </a:r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      0                 5                 10              20                40                50 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CasellaDiTesto 26"/>
              <p:cNvSpPr txBox="1"/>
              <p:nvPr/>
            </p:nvSpPr>
            <p:spPr>
              <a:xfrm>
                <a:off x="6173559" y="2784058"/>
                <a:ext cx="47034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matinib</a:t>
                </a:r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µM)         0                0.1              0.2              0.5                1                 5 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3" name="Gruppo 32"/>
            <p:cNvGrpSpPr/>
            <p:nvPr/>
          </p:nvGrpSpPr>
          <p:grpSpPr>
            <a:xfrm>
              <a:off x="1013843" y="3095034"/>
              <a:ext cx="4143275" cy="2140495"/>
              <a:chOff x="1013843" y="3214780"/>
              <a:chExt cx="4143275" cy="2140495"/>
            </a:xfrm>
          </p:grpSpPr>
          <p:graphicFrame>
            <p:nvGraphicFramePr>
              <p:cNvPr id="21" name="Grafico 2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83739763"/>
                  </p:ext>
                </p:extLst>
              </p:nvPr>
            </p:nvGraphicFramePr>
            <p:xfrm>
              <a:off x="1170296" y="3214780"/>
              <a:ext cx="3986822" cy="214049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23" name="CasellaDiTesto 22"/>
              <p:cNvSpPr txBox="1"/>
              <p:nvPr/>
            </p:nvSpPr>
            <p:spPr>
              <a:xfrm>
                <a:off x="1013843" y="3328462"/>
                <a:ext cx="31290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it-IT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0" name="Connettore 1 29"/>
              <p:cNvCxnSpPr/>
              <p:nvPr/>
            </p:nvCxnSpPr>
            <p:spPr>
              <a:xfrm>
                <a:off x="1709057" y="3853543"/>
                <a:ext cx="344806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uppo 31"/>
            <p:cNvGrpSpPr/>
            <p:nvPr/>
          </p:nvGrpSpPr>
          <p:grpSpPr>
            <a:xfrm>
              <a:off x="6628444" y="3271746"/>
              <a:ext cx="4671971" cy="2121332"/>
              <a:chOff x="6628444" y="3315290"/>
              <a:chExt cx="4671971" cy="2121332"/>
            </a:xfrm>
          </p:grpSpPr>
          <p:graphicFrame>
            <p:nvGraphicFramePr>
              <p:cNvPr id="16" name="Grafico 1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3969233"/>
                  </p:ext>
                </p:extLst>
              </p:nvPr>
            </p:nvGraphicFramePr>
            <p:xfrm>
              <a:off x="6916999" y="3315290"/>
              <a:ext cx="4383416" cy="212133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9" name="CasellaDiTesto 18"/>
              <p:cNvSpPr txBox="1"/>
              <p:nvPr/>
            </p:nvSpPr>
            <p:spPr>
              <a:xfrm>
                <a:off x="6628444" y="3315290"/>
                <a:ext cx="3257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it-IT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1" name="Connettore 1 30"/>
              <p:cNvCxnSpPr/>
              <p:nvPr/>
            </p:nvCxnSpPr>
            <p:spPr>
              <a:xfrm>
                <a:off x="7505149" y="4169229"/>
                <a:ext cx="344806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4" name="CasellaDiTesto 33"/>
            <p:cNvSpPr txBox="1"/>
            <p:nvPr/>
          </p:nvSpPr>
          <p:spPr>
            <a:xfrm rot="16200000">
              <a:off x="-114291" y="1336250"/>
              <a:ext cx="16401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 </a:t>
              </a:r>
              <a:r>
                <a:rPr lang="it-IT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urvival</a:t>
              </a:r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% control)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CasellaDiTesto 34"/>
            <p:cNvSpPr txBox="1"/>
            <p:nvPr/>
          </p:nvSpPr>
          <p:spPr>
            <a:xfrm rot="16200000">
              <a:off x="5841363" y="1347136"/>
              <a:ext cx="16401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 </a:t>
              </a:r>
              <a:r>
                <a:rPr lang="it-IT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urvival</a:t>
              </a:r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% control)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527956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688</TotalTime>
  <Words>328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ontana</dc:creator>
  <cp:lastModifiedBy>Fontana</cp:lastModifiedBy>
  <cp:revision>27</cp:revision>
  <cp:lastPrinted>2018-06-15T15:27:44Z</cp:lastPrinted>
  <dcterms:created xsi:type="dcterms:W3CDTF">2018-05-31T13:22:46Z</dcterms:created>
  <dcterms:modified xsi:type="dcterms:W3CDTF">2018-06-26T08:45:08Z</dcterms:modified>
</cp:coreProperties>
</file>